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5" d="100"/>
          <a:sy n="125" d="100"/>
        </p:scale>
        <p:origin x="32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7AC22E-7499-4A37-B5BD-1F245D12BB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8B21DD8-DA45-46CD-B53A-93787F4608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1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207" indent="0" algn="ctr">
              <a:buNone/>
              <a:defRPr sz="2000"/>
            </a:lvl2pPr>
            <a:lvl3pPr marL="914413" indent="0" algn="ctr">
              <a:buNone/>
              <a:defRPr sz="1800"/>
            </a:lvl3pPr>
            <a:lvl4pPr marL="1371620" indent="0" algn="ctr">
              <a:buNone/>
              <a:defRPr sz="1600"/>
            </a:lvl4pPr>
            <a:lvl5pPr marL="1828826" indent="0" algn="ctr">
              <a:buNone/>
              <a:defRPr sz="1600"/>
            </a:lvl5pPr>
            <a:lvl6pPr marL="2286034" indent="0" algn="ctr">
              <a:buNone/>
              <a:defRPr sz="1600"/>
            </a:lvl6pPr>
            <a:lvl7pPr marL="2743239" indent="0" algn="ctr">
              <a:buNone/>
              <a:defRPr sz="1600"/>
            </a:lvl7pPr>
            <a:lvl8pPr marL="3200447" indent="0" algn="ctr">
              <a:buNone/>
              <a:defRPr sz="1600"/>
            </a:lvl8pPr>
            <a:lvl9pPr marL="3657653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315D18-C3F2-48AF-B98F-98360925A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44DA83-2552-43F5-972B-867B1C613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2E1D03-EA57-4842-AA2E-22EE8FD17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9345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608FDD-1DCF-4EE4-96DD-151C1F0C0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7473183-8AC9-4E05-ADA0-B5C01695F5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1F2909-3F60-4A56-8D03-8FE8D748F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963026-A52C-4CE8-BCA1-476949026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AF50AC4-1D3D-475D-A9D0-4E4632FF3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2783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E6748B4-31DC-4998-B404-D45C8A383C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3" y="365125"/>
            <a:ext cx="2628899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66E4D26-2460-4008-9FC2-D698E77374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0A30EE-3D28-4220-967A-C094D0BB1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557782-CAD0-4FF2-9254-A7DC082419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CBC7AB-6C21-4799-8433-3401FE2EB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82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869CEF-E351-4FAF-8FAA-01F6D6CF2F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C2B4A02-FB1F-459A-A817-7185C9BAED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2947BF-B445-4D60-9728-D97995898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3373BA-ADE4-4919-89D9-2311A19DA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EFE39C-3E9A-44B6-B447-46774C1C9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058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FA64F7-B8DB-4EF6-B1FC-FBA5EAEFEB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42"/>
            <a:ext cx="10515601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E508D53-7F88-47F1-8A4A-A91FBA125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7"/>
            <a:ext cx="10515601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1pPr>
            <a:lvl2pPr marL="45720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5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8304D2-BD58-426F-9792-2380C3678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A36344-F309-41DA-ACC6-CC8FBE438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A412A7-F13F-4523-AA95-3A46666E6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0682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569E3-3F77-4D36-BA04-F178AB5C75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2B5AA3E-4E8B-46CD-8152-5E6BFBACC2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FD96209-F5C5-4A14-B3AF-9A51FC1049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6A8455A-83E2-4BFE-80A6-41E012B37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774F7F-2DDF-47D3-B405-12E2B4E40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8040583-9896-4375-B1FC-55B1DEC91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3144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EAD59A-BECE-4728-B587-220CC7C926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9"/>
            <a:ext cx="10515601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4FE28A5-5239-4342-BE03-F671C6BCBA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07" indent="0">
              <a:buNone/>
              <a:defRPr sz="2000" b="1"/>
            </a:lvl2pPr>
            <a:lvl3pPr marL="914413" indent="0">
              <a:buNone/>
              <a:defRPr sz="1800" b="1"/>
            </a:lvl3pPr>
            <a:lvl4pPr marL="1371620" indent="0">
              <a:buNone/>
              <a:defRPr sz="1600" b="1"/>
            </a:lvl4pPr>
            <a:lvl5pPr marL="1828826" indent="0">
              <a:buNone/>
              <a:defRPr sz="1600" b="1"/>
            </a:lvl5pPr>
            <a:lvl6pPr marL="2286034" indent="0">
              <a:buNone/>
              <a:defRPr sz="1600" b="1"/>
            </a:lvl6pPr>
            <a:lvl7pPr marL="2743239" indent="0">
              <a:buNone/>
              <a:defRPr sz="1600" b="1"/>
            </a:lvl7pPr>
            <a:lvl8pPr marL="3200447" indent="0">
              <a:buNone/>
              <a:defRPr sz="1600" b="1"/>
            </a:lvl8pPr>
            <a:lvl9pPr marL="3657653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806C856-92B8-48A0-BF69-1B1BCB5771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723978E-347B-4962-ACD4-EF4B5D8430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07" indent="0">
              <a:buNone/>
              <a:defRPr sz="2000" b="1"/>
            </a:lvl2pPr>
            <a:lvl3pPr marL="914413" indent="0">
              <a:buNone/>
              <a:defRPr sz="1800" b="1"/>
            </a:lvl3pPr>
            <a:lvl4pPr marL="1371620" indent="0">
              <a:buNone/>
              <a:defRPr sz="1600" b="1"/>
            </a:lvl4pPr>
            <a:lvl5pPr marL="1828826" indent="0">
              <a:buNone/>
              <a:defRPr sz="1600" b="1"/>
            </a:lvl5pPr>
            <a:lvl6pPr marL="2286034" indent="0">
              <a:buNone/>
              <a:defRPr sz="1600" b="1"/>
            </a:lvl6pPr>
            <a:lvl7pPr marL="2743239" indent="0">
              <a:buNone/>
              <a:defRPr sz="1600" b="1"/>
            </a:lvl7pPr>
            <a:lvl8pPr marL="3200447" indent="0">
              <a:buNone/>
              <a:defRPr sz="1600" b="1"/>
            </a:lvl8pPr>
            <a:lvl9pPr marL="3657653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B96B2C1-F06A-413D-A825-9B05DF66CB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122A54E-F30D-4685-877C-48B38CA27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229C29C-3545-45EA-8179-5B47514A4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F3E617A-57FB-4E42-98EF-D85408D62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48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CF0CA7-A193-4CA6-89A6-D3FDAC50BE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C78BEE4-3D7A-40D6-A414-63F1C626E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B1E5E42-DE33-4BBE-8E71-2A8F89FC3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1C87D41-6DB4-48AC-948E-0C6924D94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1678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FE7F539-A7DC-4E63-8CCF-BD630E23A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E75C165-1F5E-49F9-811D-E13ABED1F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EA348CD-2909-43DF-A105-B2AB287EC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402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7501FD-07F7-4A80-AC98-BC2923ACE5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37969B4-5D0E-4FB4-A61A-DB243D55F5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F57278A-386F-484C-92C2-431D724F54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7" indent="0">
              <a:buNone/>
              <a:defRPr sz="1399"/>
            </a:lvl2pPr>
            <a:lvl3pPr marL="914413" indent="0">
              <a:buNone/>
              <a:defRPr sz="1200"/>
            </a:lvl3pPr>
            <a:lvl4pPr marL="1371620" indent="0">
              <a:buNone/>
              <a:defRPr sz="1000"/>
            </a:lvl4pPr>
            <a:lvl5pPr marL="1828826" indent="0">
              <a:buNone/>
              <a:defRPr sz="1000"/>
            </a:lvl5pPr>
            <a:lvl6pPr marL="2286034" indent="0">
              <a:buNone/>
              <a:defRPr sz="1000"/>
            </a:lvl6pPr>
            <a:lvl7pPr marL="2743239" indent="0">
              <a:buNone/>
              <a:defRPr sz="1000"/>
            </a:lvl7pPr>
            <a:lvl8pPr marL="3200447" indent="0">
              <a:buNone/>
              <a:defRPr sz="1000"/>
            </a:lvl8pPr>
            <a:lvl9pPr marL="3657653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05F553-C8CF-4670-9B79-9B3CD9206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DEF524-9FAB-4995-96DC-CD999379B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27AB7A-B9D5-4C2F-AA74-F0CA9D64A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126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3DC2ED-6FB9-4896-8335-A757E0FBB3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7D3A018-31B0-423C-97CA-0BF1FE47EC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7" indent="0">
              <a:buNone/>
              <a:defRPr sz="2800"/>
            </a:lvl2pPr>
            <a:lvl3pPr marL="914413" indent="0">
              <a:buNone/>
              <a:defRPr sz="2401"/>
            </a:lvl3pPr>
            <a:lvl4pPr marL="1371620" indent="0">
              <a:buNone/>
              <a:defRPr sz="2000"/>
            </a:lvl4pPr>
            <a:lvl5pPr marL="1828826" indent="0">
              <a:buNone/>
              <a:defRPr sz="2000"/>
            </a:lvl5pPr>
            <a:lvl6pPr marL="2286034" indent="0">
              <a:buNone/>
              <a:defRPr sz="2000"/>
            </a:lvl6pPr>
            <a:lvl7pPr marL="2743239" indent="0">
              <a:buNone/>
              <a:defRPr sz="2000"/>
            </a:lvl7pPr>
            <a:lvl8pPr marL="3200447" indent="0">
              <a:buNone/>
              <a:defRPr sz="2000"/>
            </a:lvl8pPr>
            <a:lvl9pPr marL="3657653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2D81746-CB5F-462B-8031-99210F52AB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7" indent="0">
              <a:buNone/>
              <a:defRPr sz="1399"/>
            </a:lvl2pPr>
            <a:lvl3pPr marL="914413" indent="0">
              <a:buNone/>
              <a:defRPr sz="1200"/>
            </a:lvl3pPr>
            <a:lvl4pPr marL="1371620" indent="0">
              <a:buNone/>
              <a:defRPr sz="1000"/>
            </a:lvl4pPr>
            <a:lvl5pPr marL="1828826" indent="0">
              <a:buNone/>
              <a:defRPr sz="1000"/>
            </a:lvl5pPr>
            <a:lvl6pPr marL="2286034" indent="0">
              <a:buNone/>
              <a:defRPr sz="1000"/>
            </a:lvl6pPr>
            <a:lvl7pPr marL="2743239" indent="0">
              <a:buNone/>
              <a:defRPr sz="1000"/>
            </a:lvl7pPr>
            <a:lvl8pPr marL="3200447" indent="0">
              <a:buNone/>
              <a:defRPr sz="1000"/>
            </a:lvl8pPr>
            <a:lvl9pPr marL="3657653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5E44D3-917F-4148-ADC7-A0BD2405B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7C2D40-5134-42A2-AEF1-6EC744456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67215A-1655-488B-B0B3-69B254DA6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253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DFE48F3-F2A6-4D60-AF92-B2D55946D9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1" y="365129"/>
            <a:ext cx="1051560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A4F9EBB-0C56-4B8D-821D-CE31B9C5FF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43F66A-CB53-4DBD-A566-EEEA2F9E31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78207-78F4-4E0A-8A50-D54899566D75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6B116-B167-458F-B093-425EDC0CCC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80EFDE-DA9D-4210-8323-C306785E95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17C584-C090-499E-9FBF-B95B9A2DD9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4822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5" indent="-228605" algn="l" defTabSz="91441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1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8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4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31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7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44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50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58" indent="-228605" algn="l" defTabSz="91441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7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3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20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6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34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9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7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53" algn="l" defTabSz="91441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5E04541A-13E4-4103-9DB7-2DFBAB204E9D}"/>
              </a:ext>
            </a:extLst>
          </p:cNvPr>
          <p:cNvGrpSpPr/>
          <p:nvPr/>
        </p:nvGrpSpPr>
        <p:grpSpPr>
          <a:xfrm>
            <a:off x="1454387" y="2380805"/>
            <a:ext cx="2893670" cy="2836908"/>
            <a:chOff x="2579780" y="2471924"/>
            <a:chExt cx="2893670" cy="2836908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93F2EB2B-5969-4AE9-9581-ECB5BD048B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5400000">
              <a:off x="2896061" y="2731443"/>
              <a:ext cx="2836908" cy="2317870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0AA607F2-69F3-4291-8ACC-6708926D78E5}"/>
                </a:ext>
              </a:extLst>
            </p:cNvPr>
            <p:cNvSpPr txBox="1"/>
            <p:nvPr/>
          </p:nvSpPr>
          <p:spPr>
            <a:xfrm>
              <a:off x="2579781" y="250579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EC42A97-840D-481C-97EF-25282C1F5005}"/>
                </a:ext>
              </a:extLst>
            </p:cNvPr>
            <p:cNvSpPr txBox="1"/>
            <p:nvPr/>
          </p:nvSpPr>
          <p:spPr>
            <a:xfrm>
              <a:off x="2579781" y="2806321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264E323-E64F-41EA-B689-E106AF26BA47}"/>
                </a:ext>
              </a:extLst>
            </p:cNvPr>
            <p:cNvSpPr txBox="1"/>
            <p:nvPr/>
          </p:nvSpPr>
          <p:spPr>
            <a:xfrm>
              <a:off x="2579781" y="3106843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DA7E85F-B08D-4102-A49A-98DBD6966C42}"/>
                </a:ext>
              </a:extLst>
            </p:cNvPr>
            <p:cNvSpPr txBox="1"/>
            <p:nvPr/>
          </p:nvSpPr>
          <p:spPr>
            <a:xfrm>
              <a:off x="2579781" y="3398526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19491A6A-9115-43C8-99FE-2D1AE017DF71}"/>
                </a:ext>
              </a:extLst>
            </p:cNvPr>
            <p:cNvSpPr txBox="1"/>
            <p:nvPr/>
          </p:nvSpPr>
          <p:spPr>
            <a:xfrm>
              <a:off x="2579781" y="3685468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AED08C5-3636-44BB-917C-EAF03952D18A}"/>
                </a:ext>
              </a:extLst>
            </p:cNvPr>
            <p:cNvSpPr txBox="1"/>
            <p:nvPr/>
          </p:nvSpPr>
          <p:spPr>
            <a:xfrm>
              <a:off x="2579781" y="3977005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F474368-6AEF-4E6D-AF53-4EB23424480E}"/>
                </a:ext>
              </a:extLst>
            </p:cNvPr>
            <p:cNvSpPr txBox="1"/>
            <p:nvPr/>
          </p:nvSpPr>
          <p:spPr>
            <a:xfrm>
              <a:off x="2579780" y="4279600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7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51E1C6A-6A53-45C4-80A5-9B8E8CC4FB9C}"/>
                </a:ext>
              </a:extLst>
            </p:cNvPr>
            <p:cNvSpPr txBox="1"/>
            <p:nvPr/>
          </p:nvSpPr>
          <p:spPr>
            <a:xfrm>
              <a:off x="2579780" y="4544572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8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484039F2-9394-47E0-8781-F9BB79F04A4A}"/>
                </a:ext>
              </a:extLst>
            </p:cNvPr>
            <p:cNvSpPr txBox="1"/>
            <p:nvPr/>
          </p:nvSpPr>
          <p:spPr>
            <a:xfrm>
              <a:off x="2579780" y="4864740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i9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1C80E709-9E75-44D2-B43B-A751CCC752DC}"/>
              </a:ext>
            </a:extLst>
          </p:cNvPr>
          <p:cNvGrpSpPr/>
          <p:nvPr/>
        </p:nvGrpSpPr>
        <p:grpSpPr>
          <a:xfrm>
            <a:off x="4943822" y="1715555"/>
            <a:ext cx="3006243" cy="4167408"/>
            <a:chOff x="4977402" y="1756976"/>
            <a:chExt cx="3006243" cy="4167408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E9A39ED-6F1B-4B26-9150-5EBC4BA36D9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4712430" y="2653168"/>
              <a:ext cx="4167408" cy="2375023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77EDA82-394D-42C1-B345-21C0A647A494}"/>
                </a:ext>
              </a:extLst>
            </p:cNvPr>
            <p:cNvSpPr txBox="1"/>
            <p:nvPr/>
          </p:nvSpPr>
          <p:spPr>
            <a:xfrm>
              <a:off x="4983111" y="1841003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1B10B376-A1B9-4E44-8C7D-49D0ADA316B5}"/>
                </a:ext>
              </a:extLst>
            </p:cNvPr>
            <p:cNvSpPr txBox="1"/>
            <p:nvPr/>
          </p:nvSpPr>
          <p:spPr>
            <a:xfrm>
              <a:off x="4983111" y="2141525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1542D4E-4E7D-4B8D-98B2-2E8EDB7CECC9}"/>
                </a:ext>
              </a:extLst>
            </p:cNvPr>
            <p:cNvSpPr txBox="1"/>
            <p:nvPr/>
          </p:nvSpPr>
          <p:spPr>
            <a:xfrm>
              <a:off x="4983110" y="241393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6976952-B799-4A6D-8453-9AF23A8046BB}"/>
                </a:ext>
              </a:extLst>
            </p:cNvPr>
            <p:cNvSpPr txBox="1"/>
            <p:nvPr/>
          </p:nvSpPr>
          <p:spPr>
            <a:xfrm>
              <a:off x="4983110" y="2696877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5A72BD00-3870-4F90-8E92-683A53091E06}"/>
                </a:ext>
              </a:extLst>
            </p:cNvPr>
            <p:cNvSpPr txBox="1"/>
            <p:nvPr/>
          </p:nvSpPr>
          <p:spPr>
            <a:xfrm>
              <a:off x="4983110" y="300186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50BA7406-B19B-4DE1-96F7-334F8C92E2F6}"/>
                </a:ext>
              </a:extLst>
            </p:cNvPr>
            <p:cNvSpPr txBox="1"/>
            <p:nvPr/>
          </p:nvSpPr>
          <p:spPr>
            <a:xfrm>
              <a:off x="4983110" y="3283847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7423EE4-6B59-48A3-AA69-5D43B3C3D4D3}"/>
                </a:ext>
              </a:extLst>
            </p:cNvPr>
            <p:cNvSpPr txBox="1"/>
            <p:nvPr/>
          </p:nvSpPr>
          <p:spPr>
            <a:xfrm>
              <a:off x="4983110" y="3567365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7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FA748FAA-9CAA-41C8-BE6E-79A1C1BEA30C}"/>
                </a:ext>
              </a:extLst>
            </p:cNvPr>
            <p:cNvSpPr txBox="1"/>
            <p:nvPr/>
          </p:nvSpPr>
          <p:spPr>
            <a:xfrm>
              <a:off x="4983110" y="3833015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8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53008D2B-581C-4C72-8639-4448E2ECE8D0}"/>
                </a:ext>
              </a:extLst>
            </p:cNvPr>
            <p:cNvSpPr txBox="1"/>
            <p:nvPr/>
          </p:nvSpPr>
          <p:spPr>
            <a:xfrm>
              <a:off x="4983110" y="4116484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9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992C04BB-A1F5-4CC8-B768-0FB0E5846082}"/>
                </a:ext>
              </a:extLst>
            </p:cNvPr>
            <p:cNvSpPr txBox="1"/>
            <p:nvPr/>
          </p:nvSpPr>
          <p:spPr>
            <a:xfrm>
              <a:off x="4983110" y="441137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3FA1C521-318D-4F2B-A34B-C605EE376568}"/>
                </a:ext>
              </a:extLst>
            </p:cNvPr>
            <p:cNvSpPr txBox="1"/>
            <p:nvPr/>
          </p:nvSpPr>
          <p:spPr>
            <a:xfrm>
              <a:off x="4983110" y="4694894"/>
              <a:ext cx="666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3C7D2A64-A759-407E-992E-9F9C8C87FDFC}"/>
                </a:ext>
              </a:extLst>
            </p:cNvPr>
            <p:cNvSpPr txBox="1"/>
            <p:nvPr/>
          </p:nvSpPr>
          <p:spPr>
            <a:xfrm>
              <a:off x="4983110" y="4953170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0C52CB94-BF66-4124-97EF-AB59FCE09C13}"/>
                </a:ext>
              </a:extLst>
            </p:cNvPr>
            <p:cNvSpPr txBox="1"/>
            <p:nvPr/>
          </p:nvSpPr>
          <p:spPr>
            <a:xfrm>
              <a:off x="4977402" y="526190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20377F3B-F07D-4D8A-B766-00E227820326}"/>
              </a:ext>
            </a:extLst>
          </p:cNvPr>
          <p:cNvGrpSpPr/>
          <p:nvPr/>
        </p:nvGrpSpPr>
        <p:grpSpPr>
          <a:xfrm>
            <a:off x="8575578" y="1119689"/>
            <a:ext cx="1490616" cy="5226318"/>
            <a:chOff x="8420346" y="1092705"/>
            <a:chExt cx="1490616" cy="5226318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B6D70FCB-C4B5-41E3-84D6-4C1879DB9F3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5400000">
              <a:off x="6777076" y="3185137"/>
              <a:ext cx="5226318" cy="1041454"/>
            </a:xfrm>
            <a:prstGeom prst="rect">
              <a:avLst/>
            </a:prstGeom>
          </p:spPr>
        </p:pic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540AC91C-6B5D-4E5C-B38B-54DEA46C0974}"/>
                </a:ext>
              </a:extLst>
            </p:cNvPr>
            <p:cNvSpPr txBox="1"/>
            <p:nvPr/>
          </p:nvSpPr>
          <p:spPr>
            <a:xfrm>
              <a:off x="8420346" y="1133361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3CA0439-6CE3-46DA-8FB5-2D2CEADFDB1F}"/>
                </a:ext>
              </a:extLst>
            </p:cNvPr>
            <p:cNvSpPr txBox="1"/>
            <p:nvPr/>
          </p:nvSpPr>
          <p:spPr>
            <a:xfrm>
              <a:off x="8420346" y="1395128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AE022D4-4183-4576-8E39-D4B2B3B4415D}"/>
                </a:ext>
              </a:extLst>
            </p:cNvPr>
            <p:cNvSpPr txBox="1"/>
            <p:nvPr/>
          </p:nvSpPr>
          <p:spPr>
            <a:xfrm>
              <a:off x="8420346" y="1653199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EB01D3FC-EA55-4D18-803E-40B03B20D24F}"/>
                </a:ext>
              </a:extLst>
            </p:cNvPr>
            <p:cNvSpPr txBox="1"/>
            <p:nvPr/>
          </p:nvSpPr>
          <p:spPr>
            <a:xfrm>
              <a:off x="8420346" y="1924244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13A938F1-58C8-472B-9831-F7A0FE2D4786}"/>
                </a:ext>
              </a:extLst>
            </p:cNvPr>
            <p:cNvSpPr txBox="1"/>
            <p:nvPr/>
          </p:nvSpPr>
          <p:spPr>
            <a:xfrm>
              <a:off x="8420346" y="2143141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046B03BC-B31D-4BB6-8ED0-3F1927036274}"/>
                </a:ext>
              </a:extLst>
            </p:cNvPr>
            <p:cNvSpPr txBox="1"/>
            <p:nvPr/>
          </p:nvSpPr>
          <p:spPr>
            <a:xfrm>
              <a:off x="8420346" y="2402363"/>
              <a:ext cx="449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0B46F3C5-6554-49BB-B796-09F5D0B12C14}"/>
                </a:ext>
              </a:extLst>
            </p:cNvPr>
            <p:cNvSpPr txBox="1"/>
            <p:nvPr/>
          </p:nvSpPr>
          <p:spPr>
            <a:xfrm>
              <a:off x="8420346" y="2679362"/>
              <a:ext cx="449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7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BDDE2C2E-2D76-4099-B0BA-60EFE24A9EB7}"/>
                </a:ext>
              </a:extLst>
            </p:cNvPr>
            <p:cNvSpPr txBox="1"/>
            <p:nvPr/>
          </p:nvSpPr>
          <p:spPr>
            <a:xfrm>
              <a:off x="8420346" y="2932172"/>
              <a:ext cx="449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8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503EA5BA-1521-4E28-8B53-8E6186C724A3}"/>
                </a:ext>
              </a:extLst>
            </p:cNvPr>
            <p:cNvSpPr txBox="1"/>
            <p:nvPr/>
          </p:nvSpPr>
          <p:spPr>
            <a:xfrm>
              <a:off x="8420346" y="3184982"/>
              <a:ext cx="449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9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FEB5A0CA-5012-49FF-BAF8-14E9FEA32D75}"/>
                </a:ext>
              </a:extLst>
            </p:cNvPr>
            <p:cNvSpPr txBox="1"/>
            <p:nvPr/>
          </p:nvSpPr>
          <p:spPr>
            <a:xfrm>
              <a:off x="8420346" y="3437792"/>
              <a:ext cx="5598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5EEE1E6A-84CA-47B4-9E23-18D3B4E8037E}"/>
                </a:ext>
              </a:extLst>
            </p:cNvPr>
            <p:cNvSpPr txBox="1"/>
            <p:nvPr/>
          </p:nvSpPr>
          <p:spPr>
            <a:xfrm>
              <a:off x="8420346" y="3699237"/>
              <a:ext cx="529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EDE7D66E-D593-4DA3-9C57-824A91202338}"/>
                </a:ext>
              </a:extLst>
            </p:cNvPr>
            <p:cNvSpPr txBox="1"/>
            <p:nvPr/>
          </p:nvSpPr>
          <p:spPr>
            <a:xfrm>
              <a:off x="8420346" y="3918275"/>
              <a:ext cx="529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7C05217B-AEC6-4E40-880F-4089BD462C80}"/>
                </a:ext>
              </a:extLst>
            </p:cNvPr>
            <p:cNvSpPr txBox="1"/>
            <p:nvPr/>
          </p:nvSpPr>
          <p:spPr>
            <a:xfrm>
              <a:off x="8420346" y="4219922"/>
              <a:ext cx="529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07DA1FE8-12D2-41EF-A8FD-F86CD3B1EC4A}"/>
                </a:ext>
              </a:extLst>
            </p:cNvPr>
            <p:cNvSpPr txBox="1"/>
            <p:nvPr/>
          </p:nvSpPr>
          <p:spPr>
            <a:xfrm>
              <a:off x="8420346" y="4481555"/>
              <a:ext cx="529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4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A900BD4C-7FE2-4BD2-9B8E-1793B309E7FB}"/>
                </a:ext>
              </a:extLst>
            </p:cNvPr>
            <p:cNvSpPr txBox="1"/>
            <p:nvPr/>
          </p:nvSpPr>
          <p:spPr>
            <a:xfrm>
              <a:off x="8420346" y="4734120"/>
              <a:ext cx="54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031AAE43-D9F6-4DD1-8F3D-390480B579D8}"/>
                </a:ext>
              </a:extLst>
            </p:cNvPr>
            <p:cNvSpPr txBox="1"/>
            <p:nvPr/>
          </p:nvSpPr>
          <p:spPr>
            <a:xfrm>
              <a:off x="8420346" y="5014737"/>
              <a:ext cx="536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2A2EBCFC-A448-4E69-A79F-A440D2AD3F77}"/>
                </a:ext>
              </a:extLst>
            </p:cNvPr>
            <p:cNvSpPr txBox="1"/>
            <p:nvPr/>
          </p:nvSpPr>
          <p:spPr>
            <a:xfrm>
              <a:off x="8420346" y="5250331"/>
              <a:ext cx="529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7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EEB26207-4567-496D-A900-C140B8DB274B}"/>
                </a:ext>
              </a:extLst>
            </p:cNvPr>
            <p:cNvSpPr txBox="1"/>
            <p:nvPr/>
          </p:nvSpPr>
          <p:spPr>
            <a:xfrm>
              <a:off x="8420346" y="5507261"/>
              <a:ext cx="5331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8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BE95A7B0-869D-40CE-A72D-8B90288A7436}"/>
                </a:ext>
              </a:extLst>
            </p:cNvPr>
            <p:cNvSpPr txBox="1"/>
            <p:nvPr/>
          </p:nvSpPr>
          <p:spPr>
            <a:xfrm>
              <a:off x="8420346" y="5761497"/>
              <a:ext cx="5331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9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矩形 56">
            <a:extLst>
              <a:ext uri="{FF2B5EF4-FFF2-40B4-BE49-F238E27FC236}">
                <a16:creationId xmlns:a16="http://schemas.microsoft.com/office/drawing/2014/main" id="{CF448CD7-996B-4216-89D0-DFE3BBC235B4}"/>
              </a:ext>
            </a:extLst>
          </p:cNvPr>
          <p:cNvSpPr/>
          <p:nvPr/>
        </p:nvSpPr>
        <p:spPr>
          <a:xfrm>
            <a:off x="1513555" y="5122382"/>
            <a:ext cx="213712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aicalensis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romosomes</a:t>
            </a:r>
            <a:endParaRPr lang="zh-CN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60606B3A-DBBC-413D-AB96-A9E6028A0E5E}"/>
              </a:ext>
            </a:extLst>
          </p:cNvPr>
          <p:cNvSpPr/>
          <p:nvPr/>
        </p:nvSpPr>
        <p:spPr>
          <a:xfrm>
            <a:off x="5067695" y="5594789"/>
            <a:ext cx="18998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arbat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hromosome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9C14334E-E83E-4333-A91D-33EA1A24AF78}"/>
              </a:ext>
            </a:extLst>
          </p:cNvPr>
          <p:cNvSpPr/>
          <p:nvPr/>
        </p:nvSpPr>
        <p:spPr>
          <a:xfrm>
            <a:off x="8471140" y="6081332"/>
            <a:ext cx="18628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V. vinifer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hromosome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5625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53</Words>
  <Application>Microsoft Office PowerPoint</Application>
  <PresentationFormat>宽屏</PresentationFormat>
  <Paragraphs>4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7</cp:revision>
  <dcterms:created xsi:type="dcterms:W3CDTF">2020-02-20T13:13:28Z</dcterms:created>
  <dcterms:modified xsi:type="dcterms:W3CDTF">2020-10-23T06:14:57Z</dcterms:modified>
</cp:coreProperties>
</file>